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0C0C2-CFE4-48FE-8B29-352542E350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7E653-1AE6-4456-8459-B23D715D61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40AAE3-875B-4121-86C5-36CB352C7F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48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660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27313-082D-4F6B-9AFA-885979F4B3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9E80F-AB4B-410D-A779-4E98739B57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4981D-DB36-4F0E-A910-040A9A21C0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5A1A3-AAEA-4B76-AB41-B658DF88F3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36D87-9EA7-432C-8CD8-ACB4847982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DFA461-40E2-4750-86B1-3918308638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54CA5-5831-45BE-95C4-DB3BD22338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66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CC79B-89A4-4024-A190-E787A0EBEB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480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660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7E652-E882-4222-A757-7F30506AEE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480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788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C7E38C-2A7B-4434-9919-745C0903CAEB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85800" y="8383680"/>
            <a:ext cx="5791320" cy="46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8000" rIns="18000" tIns="36000" bIns="36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Distributions of 1000-grain weight in the four NIL populations grown in Zhejiang and Hainan, respectively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550800" y="382680"/>
            <a:ext cx="5850000" cy="8001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02T02:57:20Z</dcterms:created>
  <dc:creator>Administrator</dc:creator>
  <dc:description/>
  <dc:language>en-US</dc:language>
  <cp:lastModifiedBy>Reviewer</cp:lastModifiedBy>
  <dcterms:modified xsi:type="dcterms:W3CDTF">2016-06-03T01:37:54Z</dcterms:modified>
  <cp:revision>2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